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793" autoAdjust="0"/>
    <p:restoredTop sz="96327"/>
  </p:normalViewPr>
  <p:slideViewPr>
    <p:cSldViewPr snapToGrid="0">
      <p:cViewPr varScale="1">
        <p:scale>
          <a:sx n="123" d="100"/>
          <a:sy n="123" d="100"/>
        </p:scale>
        <p:origin x="808"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855632-936B-419C-8D24-FA2AC0F024D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657C8762-DEFA-492D-82CA-F2F06580D21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2381BF9A-8CCC-4400-8284-7046A044C653}"/>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99878238-C649-4044-95F9-56D3BD372DA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F8972D2-8826-4900-A292-F02DAAEA1DBC}"/>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34413986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C7AEAE-7B14-4D54-BB88-5DC28B2B5608}"/>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E1CD73BD-EE66-4CF6-868F-1895AD96AA2B}"/>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A61A27F-0EFD-4E07-80E7-7E42A7EA063A}"/>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015756E4-D3AF-4149-A20A-CB039542BA2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FB86831-933A-4A76-9302-9284800449FE}"/>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27152026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83F01D2-6386-47B1-BE9B-0DCF46A43292}"/>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58E59F4-DC6D-47AC-B471-6CF626CA974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B1D5891-BA0A-4D80-99D4-F748D8D8CB14}"/>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83E54CBF-5D7D-435D-A8F9-812A12DF6CD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884AEE4-972B-45AB-809F-0ABA124AA58A}"/>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4029883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93E79E-E150-4591-9706-DA7F104C1443}"/>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6AAEBC8D-83D3-4987-8682-70C450C2737C}"/>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A264C2A-877B-47F4-8802-B5029914BF4D}"/>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7979E539-DB34-42AE-A74C-A301A8FFAE6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06776E8-F599-4E22-AB15-B843C23E25A7}"/>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25454096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8EF005-99D0-4E86-A4C2-4931906BD6D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1FBD1BFF-00B7-47AA-B13C-03D30988FFC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395AE90-734C-4C4B-A7B0-1507521E781A}"/>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82AE04D0-9F7D-45A8-B4D4-51446F40DF4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3885B0C-A7BE-42B4-B248-4847C34FD984}"/>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1901544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A2900B-3B77-44B1-BFE0-E8D765081530}"/>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553F4A77-0575-47D0-9E40-FB553DAFCA1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211FCC76-DA8D-4B9A-9EEC-325A7323BF5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CE60D997-73BE-48F5-8DC0-E3C6E3B5A657}"/>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6" name="Footer Placeholder 5">
            <a:extLst>
              <a:ext uri="{FF2B5EF4-FFF2-40B4-BE49-F238E27FC236}">
                <a16:creationId xmlns:a16="http://schemas.microsoft.com/office/drawing/2014/main" id="{A2A215FD-7442-47FE-BA03-487103F6ACE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7C468C8-5B56-4D4A-AFB5-B36DEDF4CA69}"/>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447595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94425D-3BF6-4EDD-9B92-FC4F73FFF0D3}"/>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D9659FD-5834-411B-94FB-56082976B0A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227E20E6-D9BF-4A1A-B095-3842D295DC97}"/>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0ADFCEDC-B113-44C9-A622-1AB7A0DFC1A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06F24A9-57A7-400C-9A36-446A45811A7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756A6610-D79B-483C-84E8-DDED2DDCDF17}"/>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8" name="Footer Placeholder 7">
            <a:extLst>
              <a:ext uri="{FF2B5EF4-FFF2-40B4-BE49-F238E27FC236}">
                <a16:creationId xmlns:a16="http://schemas.microsoft.com/office/drawing/2014/main" id="{31AB1B6C-2564-4361-B5C0-74AB2996F46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87C1D3E9-A157-4651-866F-329080A9A8CD}"/>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29295403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80562D-44E1-4F2C-B560-B129CC606397}"/>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6A45FAAA-FF02-49B8-85D7-7F15519BE760}"/>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4" name="Footer Placeholder 3">
            <a:extLst>
              <a:ext uri="{FF2B5EF4-FFF2-40B4-BE49-F238E27FC236}">
                <a16:creationId xmlns:a16="http://schemas.microsoft.com/office/drawing/2014/main" id="{FB5A9929-C36F-4C35-A23D-87255F97A7EA}"/>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58AF3C0D-C2FC-443A-8EBD-88C12DD6F117}"/>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8800818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5C5DE9C-8ECF-400C-9AFE-D6C2CBFA2ED5}"/>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3" name="Footer Placeholder 2">
            <a:extLst>
              <a:ext uri="{FF2B5EF4-FFF2-40B4-BE49-F238E27FC236}">
                <a16:creationId xmlns:a16="http://schemas.microsoft.com/office/drawing/2014/main" id="{8B2BDD9C-791D-4D19-A41D-90683898DBE6}"/>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0AADEED8-7BAF-4658-B6F6-E613CB741012}"/>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5089516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7AD535-65BF-4F12-A747-BB6916BCB23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401E5890-40E5-4CD8-977C-4FB6AA9DC8B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01971C9E-25FD-40DF-B965-9AE47522C1C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E96604E-4E3B-40BA-987D-1C95E787A7C1}"/>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6" name="Footer Placeholder 5">
            <a:extLst>
              <a:ext uri="{FF2B5EF4-FFF2-40B4-BE49-F238E27FC236}">
                <a16:creationId xmlns:a16="http://schemas.microsoft.com/office/drawing/2014/main" id="{5FDF1426-83F4-4AE4-A5D8-4585D20484F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C7D4138-FF24-4CAD-B5D1-30C2702933D8}"/>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20188186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7A60A1-D1B9-4C0A-A02C-73E70A91F6A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08D1C25D-0F45-465F-81EE-8C040ACFEB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557AE1E-5627-423D-9FA5-62E2E006DF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D888CD4-02AC-4AD2-9446-61BFF9769829}"/>
              </a:ext>
            </a:extLst>
          </p:cNvPr>
          <p:cNvSpPr>
            <a:spLocks noGrp="1"/>
          </p:cNvSpPr>
          <p:nvPr>
            <p:ph type="dt" sz="half" idx="10"/>
          </p:nvPr>
        </p:nvSpPr>
        <p:spPr/>
        <p:txBody>
          <a:bodyPr/>
          <a:lstStyle/>
          <a:p>
            <a:fld id="{9ED068AA-8F06-43AB-B4A1-CC32DD0E70E2}" type="datetimeFigureOut">
              <a:rPr lang="en-GB" smtClean="0"/>
              <a:t>20/02/2022</a:t>
            </a:fld>
            <a:endParaRPr lang="en-GB"/>
          </a:p>
        </p:txBody>
      </p:sp>
      <p:sp>
        <p:nvSpPr>
          <p:cNvPr id="6" name="Footer Placeholder 5">
            <a:extLst>
              <a:ext uri="{FF2B5EF4-FFF2-40B4-BE49-F238E27FC236}">
                <a16:creationId xmlns:a16="http://schemas.microsoft.com/office/drawing/2014/main" id="{F6073C29-1DA7-4EB5-A741-715207C9E70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0978B46-59AE-46C0-A84C-E4047F609331}"/>
              </a:ext>
            </a:extLst>
          </p:cNvPr>
          <p:cNvSpPr>
            <a:spLocks noGrp="1"/>
          </p:cNvSpPr>
          <p:nvPr>
            <p:ph type="sldNum" sz="quarter" idx="12"/>
          </p:nvPr>
        </p:nvSpPr>
        <p:spPr/>
        <p:txBody>
          <a:bodyPr/>
          <a:lstStyle/>
          <a:p>
            <a:fld id="{6FCB9C4E-3ECD-47AA-B2C2-D7B220A22366}" type="slidenum">
              <a:rPr lang="en-GB" smtClean="0"/>
              <a:t>‹#›</a:t>
            </a:fld>
            <a:endParaRPr lang="en-GB"/>
          </a:p>
        </p:txBody>
      </p:sp>
    </p:spTree>
    <p:extLst>
      <p:ext uri="{BB962C8B-B14F-4D97-AF65-F5344CB8AC3E}">
        <p14:creationId xmlns:p14="http://schemas.microsoft.com/office/powerpoint/2010/main" val="2383554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C8A3C29-396D-42AE-A57B-9369D2DF64F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C8208121-E929-48E3-B0A5-D8DC243FBE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22856F3-FB9D-49D5-A1EF-589EBF5E9C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ED068AA-8F06-43AB-B4A1-CC32DD0E70E2}" type="datetimeFigureOut">
              <a:rPr lang="en-GB" smtClean="0"/>
              <a:t>20/02/2022</a:t>
            </a:fld>
            <a:endParaRPr lang="en-GB"/>
          </a:p>
        </p:txBody>
      </p:sp>
      <p:sp>
        <p:nvSpPr>
          <p:cNvPr id="5" name="Footer Placeholder 4">
            <a:extLst>
              <a:ext uri="{FF2B5EF4-FFF2-40B4-BE49-F238E27FC236}">
                <a16:creationId xmlns:a16="http://schemas.microsoft.com/office/drawing/2014/main" id="{9583A9AA-8615-4D4E-B838-04FCD12CC68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2E13245D-DAE1-4023-A988-513B7D154C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FCB9C4E-3ECD-47AA-B2C2-D7B220A22366}" type="slidenum">
              <a:rPr lang="en-GB" smtClean="0"/>
              <a:t>‹#›</a:t>
            </a:fld>
            <a:endParaRPr lang="en-GB"/>
          </a:p>
        </p:txBody>
      </p:sp>
    </p:spTree>
    <p:extLst>
      <p:ext uri="{BB962C8B-B14F-4D97-AF65-F5344CB8AC3E}">
        <p14:creationId xmlns:p14="http://schemas.microsoft.com/office/powerpoint/2010/main" val="16912848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0B7ED88-70A1-4426-B990-81C02206DFD5}"/>
              </a:ext>
            </a:extLst>
          </p:cNvPr>
          <p:cNvSpPr txBox="1"/>
          <p:nvPr/>
        </p:nvSpPr>
        <p:spPr>
          <a:xfrm>
            <a:off x="8538372" y="1892197"/>
            <a:ext cx="2565353" cy="3600986"/>
          </a:xfrm>
          <a:prstGeom prst="rect">
            <a:avLst/>
          </a:prstGeom>
          <a:noFill/>
        </p:spPr>
        <p:txBody>
          <a:bodyPr wrap="square" rtlCol="0">
            <a:spAutoFit/>
          </a:bodyPr>
          <a:lstStyle/>
          <a:p>
            <a:r>
              <a:rPr lang="en-US" sz="1200" b="1" dirty="0"/>
              <a:t>Supplementary Figure 1: </a:t>
            </a:r>
            <a:r>
              <a:rPr lang="en-US" sz="1200" dirty="0"/>
              <a:t>Variation in lesion size after inoculation with </a:t>
            </a:r>
            <a:r>
              <a:rPr lang="en-US" sz="1200" i="1" dirty="0"/>
              <a:t>B. cinerea </a:t>
            </a:r>
            <a:r>
              <a:rPr lang="en-US" sz="1200" dirty="0"/>
              <a:t>or </a:t>
            </a:r>
            <a:r>
              <a:rPr lang="en-US" sz="1200" i="1" dirty="0"/>
              <a:t>S. </a:t>
            </a:r>
            <a:r>
              <a:rPr lang="en-US" sz="1200" i="1" dirty="0" err="1"/>
              <a:t>sclerotiorum</a:t>
            </a:r>
            <a:r>
              <a:rPr lang="en-US" sz="1200" i="1" dirty="0"/>
              <a:t> </a:t>
            </a:r>
            <a:r>
              <a:rPr lang="en-US" sz="1200" dirty="0"/>
              <a:t>between lettuce types. Square root lesion size in response to </a:t>
            </a:r>
            <a:r>
              <a:rPr lang="en-US" sz="1200" i="1" dirty="0"/>
              <a:t>S. </a:t>
            </a:r>
            <a:r>
              <a:rPr lang="en-US" sz="1200" i="1" dirty="0" err="1"/>
              <a:t>sclerotiorum</a:t>
            </a:r>
            <a:r>
              <a:rPr lang="en-US" sz="1200" dirty="0"/>
              <a:t> (top) or </a:t>
            </a:r>
            <a:r>
              <a:rPr lang="en-US" sz="1200" i="1" dirty="0"/>
              <a:t>B. cinerea</a:t>
            </a:r>
            <a:r>
              <a:rPr lang="en-US" sz="1200" dirty="0"/>
              <a:t> (bottom) on detached lettuce leaves of the Lettuce Diversity Fixed Foundation Set. Grey points show individual measured lesions, violins show the distribution. Black points show REML predicted (accounting for random variation between experimental replicates). Error bars indicate REML predicted standard error. Letters shown represent Tukey HSD significance groupings (p&lt; 0.05). n = the number of lesions measured from each type in response to each pathogen.  </a:t>
            </a:r>
            <a:endParaRPr lang="en-GB" sz="1200" dirty="0"/>
          </a:p>
        </p:txBody>
      </p:sp>
      <p:pic>
        <p:nvPicPr>
          <p:cNvPr id="3" name="Picture 2">
            <a:extLst>
              <a:ext uri="{FF2B5EF4-FFF2-40B4-BE49-F238E27FC236}">
                <a16:creationId xmlns:a16="http://schemas.microsoft.com/office/drawing/2014/main" id="{58DA7862-A455-464F-9C16-0E1B51A3DA3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7474" y="0"/>
            <a:ext cx="6858000" cy="6858000"/>
          </a:xfrm>
          <a:prstGeom prst="rect">
            <a:avLst/>
          </a:prstGeom>
        </p:spPr>
      </p:pic>
    </p:spTree>
    <p:extLst>
      <p:ext uri="{BB962C8B-B14F-4D97-AF65-F5344CB8AC3E}">
        <p14:creationId xmlns:p14="http://schemas.microsoft.com/office/powerpoint/2010/main" val="13487963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40</TotalTime>
  <Words>116</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ry Pink</dc:creator>
  <cp:lastModifiedBy>Katherine Denby</cp:lastModifiedBy>
  <cp:revision>10</cp:revision>
  <dcterms:created xsi:type="dcterms:W3CDTF">2021-04-11T17:06:22Z</dcterms:created>
  <dcterms:modified xsi:type="dcterms:W3CDTF">2022-02-20T15:30:28Z</dcterms:modified>
</cp:coreProperties>
</file>